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628" y="28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1/05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1/05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1/05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1/05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1/05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1/05/2015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1/05/2015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1/05/2015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1/05/2015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1/05/2015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11/05/2015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09A6D-C09C-4548-B29A-6CF363A7E532}" type="datetimeFigureOut">
              <a:rPr lang="fr-FR" smtClean="0"/>
              <a:t>11/05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0" y="7236296"/>
            <a:ext cx="6858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oxidability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dex and ARA:EPA index.</a:t>
            </a: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achidoneat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icosapentaenoat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atio, index for inflammatory state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erum and bloo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ALS patients (ALS) and control (C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subject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Mann-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ney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est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48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(B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oxidabilit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ex in serum and blood cells from ALS patients (ALS) and control subjects (CT). *p&lt;0.05 (Mann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ne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, n=48). (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-D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:1/16:0 (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8:1/18:0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 ratio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oxidability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dex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coefficients (r)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s a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arman test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117)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-F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:1 (E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8:1 (F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ios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oxidabilit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ex. Correlation coefficients (r)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s are indicated (Spearman test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117).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2063" y="718914"/>
            <a:ext cx="4332287" cy="62293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4376303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8</TotalTime>
  <Words>145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ex</dc:creator>
  <cp:lastModifiedBy>Alex</cp:lastModifiedBy>
  <cp:revision>13</cp:revision>
  <cp:lastPrinted>2015-05-07T07:30:27Z</cp:lastPrinted>
  <dcterms:created xsi:type="dcterms:W3CDTF">2015-02-25T15:48:33Z</dcterms:created>
  <dcterms:modified xsi:type="dcterms:W3CDTF">2015-05-11T09:12:11Z</dcterms:modified>
</cp:coreProperties>
</file>